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5720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C4ADA-A3DB-4CEF-AED3-D749B01B2D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8600" y="852120"/>
            <a:ext cx="41162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8600" y="2113560"/>
            <a:ext cx="41162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7EC2F-D037-4C44-BECF-B0F8ADB9EE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8600" y="85212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337840" y="85212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8600" y="211356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337840" y="211356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CA703-94D1-44CE-B8D0-7157F549E1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8600" y="852120"/>
            <a:ext cx="132516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620360" y="852120"/>
            <a:ext cx="132516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012120" y="852120"/>
            <a:ext cx="132516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8600" y="2113560"/>
            <a:ext cx="132516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620360" y="2113560"/>
            <a:ext cx="132516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012120" y="2113560"/>
            <a:ext cx="132516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0AD19-6A5E-427A-912F-3EAAA0E7E7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8600" y="852120"/>
            <a:ext cx="4116240" cy="2414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76"/>
              </a:spcBef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16F3F-BB95-452B-87B7-DC8798E368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8600" y="852120"/>
            <a:ext cx="4116240" cy="24145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90D6E-4595-4E5D-B51C-16592CCD26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8600" y="852120"/>
            <a:ext cx="2008440" cy="24145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337840" y="852120"/>
            <a:ext cx="2008440" cy="24145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503D4-36CC-4607-AD29-C8C9CBCFEC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781DE-61A2-4441-B301-5BE5529EE8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8600" y="145800"/>
            <a:ext cx="411624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76"/>
              </a:spcBef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9B444-8810-402B-AAB7-E32CCC327E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8600" y="85212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337840" y="852120"/>
            <a:ext cx="2008440" cy="24145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8600" y="211356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FB85C-78D1-4907-A804-2980861CFA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8600" y="852120"/>
            <a:ext cx="2008440" cy="24145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337840" y="85212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337840" y="211356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62E37-58F3-4778-BE4F-87ED125105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8600" y="85212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337840" y="852120"/>
            <a:ext cx="20084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8600" y="2113560"/>
            <a:ext cx="4116240" cy="11516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E133D6-DE05-403C-99DE-DF06E8AA8E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6240" cy="6094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8600" y="852120"/>
            <a:ext cx="4116240" cy="241452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 fontScale="99000"/>
          </a:bodyPr>
          <a:p>
            <a:pPr marL="194760" indent="-19476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1" marL="419400" indent="-16164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2" marL="645480" indent="-12852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3" marL="905040" indent="-12888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4" marL="1164600" indent="-13032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5" marL="1164600" indent="-13032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6" marL="1164600" indent="-13032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8600" y="3330360"/>
            <a:ext cx="1068480" cy="25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Autofit/>
          </a:bodyPr>
          <a:lstStyle>
            <a:lvl1pPr indent="0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62040" y="3330360"/>
            <a:ext cx="1449360" cy="25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Autofit/>
          </a:bodyPr>
          <a:lstStyle>
            <a:lvl1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276360" y="3330360"/>
            <a:ext cx="1068120" cy="25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Autofit/>
          </a:bodyPr>
          <a:lstStyle>
            <a:lvl1pPr indent="0" algn="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fld id="{0166D846-A347-4345-B1BC-9B441398E873}" type="slidenum">
              <a:rPr b="0" lang="en-US" sz="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13320" y="15840"/>
            <a:ext cx="4674960" cy="3490920"/>
            <a:chOff x="-13320" y="15840"/>
            <a:chExt cx="4674960" cy="3490920"/>
          </a:xfrm>
        </p:grpSpPr>
        <p:grpSp>
          <p:nvGrpSpPr>
            <p:cNvPr id="42" name=""/>
            <p:cNvGrpSpPr/>
            <p:nvPr/>
          </p:nvGrpSpPr>
          <p:grpSpPr>
            <a:xfrm>
              <a:off x="0" y="15840"/>
              <a:ext cx="3318840" cy="2503440"/>
              <a:chOff x="0" y="15840"/>
              <a:chExt cx="3318840" cy="250344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349200" y="15840"/>
                <a:ext cx="2887560" cy="21747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44" name=""/>
              <p:cNvGrpSpPr/>
              <p:nvPr/>
            </p:nvGrpSpPr>
            <p:grpSpPr>
              <a:xfrm>
                <a:off x="741240" y="1981080"/>
                <a:ext cx="2454840" cy="307080"/>
                <a:chOff x="741240" y="1981080"/>
                <a:chExt cx="2454840" cy="307080"/>
              </a:xfrm>
            </p:grpSpPr>
            <p:sp>
              <p:nvSpPr>
                <p:cNvPr id="45" name=""/>
                <p:cNvSpPr/>
                <p:nvPr/>
              </p:nvSpPr>
              <p:spPr>
                <a:xfrm>
                  <a:off x="741240" y="2003400"/>
                  <a:ext cx="3636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-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"/>
                <p:cNvSpPr/>
                <p:nvPr/>
              </p:nvSpPr>
              <p:spPr>
                <a:xfrm>
                  <a:off x="2074680" y="2003400"/>
                  <a:ext cx="3636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>
                  <a:off x="1324440" y="1981080"/>
                  <a:ext cx="48564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 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2558160" y="2003400"/>
                  <a:ext cx="63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  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9" name=""/>
              <p:cNvSpPr/>
              <p:nvPr/>
            </p:nvSpPr>
            <p:spPr>
              <a:xfrm>
                <a:off x="407880" y="1823760"/>
                <a:ext cx="43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-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376200" y="488520"/>
                <a:ext cx="439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52160" y="988560"/>
                <a:ext cx="358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76200" y="918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52160" y="1406160"/>
                <a:ext cx="358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rot="16200000">
                <a:off x="-820800" y="864720"/>
                <a:ext cx="21009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Log2 among popula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          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varianc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303480" y="2242800"/>
                <a:ext cx="3015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Log2 within population varianc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"/>
            <p:cNvSpPr/>
            <p:nvPr/>
          </p:nvSpPr>
          <p:spPr>
            <a:xfrm>
              <a:off x="-13320" y="2682720"/>
              <a:ext cx="467496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dditional file 1.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Variation among and within populations.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Variation in gene expression among populations is correlat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ith variation averaged within reference populations (filled circles)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nd averaged within polluted populations (open circles)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21T22:47:03Z</dcterms:created>
  <dc:creator>Marla Fisher</dc:creator>
  <dc:description/>
  <dc:language>en-US</dc:language>
  <cp:lastModifiedBy>Marla Fisher</cp:lastModifiedBy>
  <dcterms:modified xsi:type="dcterms:W3CDTF">2007-04-21T22:48:53Z</dcterms:modified>
  <cp:revision>1</cp:revision>
  <dc:subject/>
  <dc:title>Slide 1</dc:title>
</cp:coreProperties>
</file>